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6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7160" autoAdjust="0"/>
  </p:normalViewPr>
  <p:slideViewPr>
    <p:cSldViewPr snapToGrid="0">
      <p:cViewPr>
        <p:scale>
          <a:sx n="100" d="100"/>
          <a:sy n="100" d="100"/>
        </p:scale>
        <p:origin x="-876" y="-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31CDAC-204B-4571-BFF8-9CD994B6642C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F965F0-5D48-4CB1-97B8-DB3F7F50C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461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DEA7F873-5C52-AD76-3570-CC4DA6B2FA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xmlns="" id="{15A487A6-5F5C-8E32-7417-95D0B669FFA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xmlns="" id="{33D68F2E-23CC-C87F-F696-68727648C3A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S6</a:t>
            </a:r>
            <a:endParaRPr kumimoji="1" lang="en-US" altLang="ja-JP" sz="1200" b="1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catter plots showing </a:t>
            </a:r>
            <a:r>
              <a:rPr kumimoji="1" lang="en-US" altLang="ja-JP"/>
              <a:t>the correlation </a:t>
            </a:r>
            <a:r>
              <a:rPr kumimoji="1" lang="en-US" altLang="ja-JP" dirty="0"/>
              <a:t>between serum cytokine levels and the proportions of T </a:t>
            </a:r>
            <a:r>
              <a:rPr kumimoji="1" lang="en-US" altLang="ja-JP"/>
              <a:t>cell subsets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AFC04CA5-2F52-0BE8-4476-D842AE63691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4F965F0-5D48-4CB1-97B8-DB3F7F50CF6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287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734142D-24DF-9C22-8F2D-A6DA214B40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62F661F5-1230-7D6E-C0C0-83D6EF6BC7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9A9F748-6A97-813F-C6CB-448DA6A6E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59041DF-F90A-0455-968E-A070F13F2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A62922E-D69B-8408-A430-136EFDED4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983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CF82D88-D4EB-73F3-E960-4DE866BEC4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69D22E24-064E-BEC0-DB03-4C69F1FDC0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30BB7F2-A740-754A-DB79-E01A0A4F4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2E4A4FA-F2B7-A639-4E0D-9183F002B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9F3F68C-3EE1-25C5-3C39-22BA0BA6E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06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8D040565-6DF5-D63A-590D-0187A84322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9ED62CBF-8C78-1B0A-4B96-4F780C9360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9BD37AF7-54C5-3B37-3C05-0515FD613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D827EE1-AA88-0941-D95F-FA688470E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3C1D100-01CC-CE05-07E4-8053DDEB1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7467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B8069F2-F129-63F2-0ABF-483FE95388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EDF7A82E-56AA-B3FA-DEBE-3D485CDF3D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D44D1A7-2EF0-85CB-8E0F-1DEBE31F5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6D50E4D-5EBB-049D-50EA-871600FA6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DAF64CA-DF0E-5D4A-3991-4A8EA48D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124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4E48299-308B-7965-29D5-425B2136F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315D56C5-9F85-AD7A-96C3-82DFE4FA4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815C89B-41F8-9599-098C-FCA29E806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BC2B4D0-7746-59C1-AB75-3DDD81CFF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0E05F13-5C14-9B4C-095A-3A7C0E826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706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8A61611-4DF4-69F5-E4AF-F229476B8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7C38496C-81ED-A92C-F68C-06AB30DA20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B749412B-CE6C-8AA5-364D-1A1D5B9E67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DAE15602-987C-4669-70BB-AE92137A5F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253C2E6-5C36-7B5E-1B1A-8CEBC55B1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FA55B48-4814-81D3-9695-D041D5631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306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1E61B35-23AA-809D-33B7-8B05297C3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0AD84AB-D793-85E8-7135-6BD3B36C70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29E9ACD3-8761-DEF9-FE18-6A84E05AE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5594CEB6-5C92-54B1-646C-F8F3628FC5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36D3A67D-87BF-2113-AE5B-225722828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6C2BCD08-2463-E534-B443-32C4E9F25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D017969C-056D-9826-D79F-6554DF971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C1A4C04C-5A67-4634-75CC-ED1376317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339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B794DF9-2079-0038-4F8B-52D635326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9A88CF4B-7DF3-20BD-99C9-E79E95A8B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CD6919D7-AA7C-5D35-D72F-ECD29AB5F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1736451A-B3B9-2A63-699C-AD2820CF6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9234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296EB4B6-640E-3EE1-B8A1-C1AD04788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2E3C33AF-B50E-61A4-516F-900CAC436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4BB35178-00E6-20DA-0E99-6D83CFC8C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119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AA4F6A0-8E34-467A-907F-2762524D1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B8DDA97D-DDFB-8C90-11AC-1F6049DE0C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4CF86B98-0315-1175-195B-E6007EBEC5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A8576EAD-8F1F-0A41-93D5-E959121ED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29992BA-08A8-D640-5B79-E5B9CEB00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9984A1BB-DA7D-2FE0-A7A5-82E69CCCE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167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8F3C4FA-BD08-7D17-C785-292CE9E96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68A88FEF-B0EA-4EF8-F5A0-880FBAAF4F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753369BE-7094-5E39-3863-4D175919EB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2EE519C3-10E5-492C-BDBF-63A2BC264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532F8E06-9ED5-BC03-F974-BD3A089D0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C5BED4C7-FAC9-B3CC-4D2B-7CFC51AE6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505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1E5501F3-1CD0-A6F2-4220-737254073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FA39278A-2BE8-C44C-95C6-469ECAEF8A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6C90F42-F498-474D-C455-8C74BE1C39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BE9F25-50ED-426A-B30F-E4826B5AB99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4D11374-6FBB-0DFA-253A-DD6B45577A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33AD363-96E7-5766-D5FF-62B3619522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7B9D919-9B6A-447C-8C43-77AB6E1AB9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16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E5C305E6-D5B3-70BC-9BF3-F35C03037E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xmlns="" id="{98A07613-BF4F-47CF-2222-30BF4307371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6739" r="45620"/>
          <a:stretch/>
        </p:blipFill>
        <p:spPr>
          <a:xfrm>
            <a:off x="3220658" y="1307075"/>
            <a:ext cx="2777375" cy="262127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xmlns="" id="{ED4A0603-216C-8973-DC28-72474A352FB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" t="46739" r="46901"/>
          <a:stretch/>
        </p:blipFill>
        <p:spPr>
          <a:xfrm>
            <a:off x="292086" y="1302772"/>
            <a:ext cx="2636386" cy="262127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xmlns="" id="{100A90B6-3439-6D6A-9B26-75826DB72B3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6739" r="46324" b="-1"/>
          <a:stretch/>
        </p:blipFill>
        <p:spPr>
          <a:xfrm>
            <a:off x="9224105" y="1307075"/>
            <a:ext cx="2699244" cy="262127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xmlns="" id="{7267583E-7ED0-3542-F6CF-34E39E2914B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" t="46739" r="47330" b="-1"/>
          <a:stretch/>
        </p:blipFill>
        <p:spPr>
          <a:xfrm>
            <a:off x="6318218" y="1307075"/>
            <a:ext cx="2578335" cy="2621273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0FCF7C2-0005-754D-2110-B6CB5F932E76}"/>
              </a:ext>
            </a:extLst>
          </p:cNvPr>
          <p:cNvSpPr txBox="1"/>
          <p:nvPr/>
        </p:nvSpPr>
        <p:spPr>
          <a:xfrm>
            <a:off x="0" y="45977"/>
            <a:ext cx="3200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8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</a:t>
            </a: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6</a:t>
            </a:r>
            <a:endParaRPr lang="en-US" altLang="ja-JP" sz="1800" b="1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xmlns="" id="{FAB1178B-21BE-2D6C-964A-1F9A30DDDB05}"/>
              </a:ext>
            </a:extLst>
          </p:cNvPr>
          <p:cNvGraphicFramePr>
            <a:graphicFrameLocks noGrp="1"/>
          </p:cNvGraphicFramePr>
          <p:nvPr/>
        </p:nvGraphicFramePr>
        <p:xfrm>
          <a:off x="2471719" y="4641208"/>
          <a:ext cx="7248561" cy="18484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01371">
                  <a:extLst>
                    <a:ext uri="{9D8B030D-6E8A-4147-A177-3AD203B41FA5}">
                      <a16:colId xmlns:a16="http://schemas.microsoft.com/office/drawing/2014/main" xmlns="" val="2838045381"/>
                    </a:ext>
                  </a:extLst>
                </a:gridCol>
                <a:gridCol w="1857829">
                  <a:extLst>
                    <a:ext uri="{9D8B030D-6E8A-4147-A177-3AD203B41FA5}">
                      <a16:colId xmlns:a16="http://schemas.microsoft.com/office/drawing/2014/main" xmlns="" val="3104430825"/>
                    </a:ext>
                  </a:extLst>
                </a:gridCol>
                <a:gridCol w="2300514">
                  <a:extLst>
                    <a:ext uri="{9D8B030D-6E8A-4147-A177-3AD203B41FA5}">
                      <a16:colId xmlns:a16="http://schemas.microsoft.com/office/drawing/2014/main" xmlns="" val="3633288784"/>
                    </a:ext>
                  </a:extLst>
                </a:gridCol>
                <a:gridCol w="1188847">
                  <a:extLst>
                    <a:ext uri="{9D8B030D-6E8A-4147-A177-3AD203B41FA5}">
                      <a16:colId xmlns:a16="http://schemas.microsoft.com/office/drawing/2014/main" xmlns="" val="3297768788"/>
                    </a:ext>
                  </a:extLst>
                </a:gridCol>
              </a:tblGrid>
              <a:tr h="36962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Peripheral T cell subpopulation 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+mn-ea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Serum cytokine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+mn-ea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Spearman's rank correlation coefficient (</a:t>
                      </a:r>
                      <a:r>
                        <a:rPr lang="el-GR" sz="1400" u="none" strike="noStrike" dirty="0">
                          <a:effectLst/>
                        </a:rPr>
                        <a:t>ρ)</a:t>
                      </a:r>
                      <a:endParaRPr lang="el-GR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P</a:t>
                      </a:r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value</a:t>
                      </a:r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(</a:t>
                      </a:r>
                      <a:r>
                        <a:rPr lang="en-US" sz="1400" u="none" strike="noStrike" dirty="0">
                          <a:effectLst/>
                        </a:rPr>
                        <a:t>Prob&gt;|</a:t>
                      </a:r>
                      <a:r>
                        <a:rPr lang="el-GR" sz="1400" u="none" strike="noStrike" dirty="0">
                          <a:effectLst/>
                        </a:rPr>
                        <a:t>ρ|)</a:t>
                      </a:r>
                      <a:endParaRPr lang="el-GR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4111618320"/>
                  </a:ext>
                </a:extLst>
              </a:tr>
              <a:tr h="3538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CD8 TEM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IL-8/CXCL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-0.2558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0.0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451054404"/>
                  </a:ext>
                </a:extLst>
              </a:tr>
              <a:tr h="3538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CD8 </a:t>
                      </a:r>
                      <a:r>
                        <a:rPr lang="en-US" sz="1400" u="none" strike="noStrike" dirty="0" err="1">
                          <a:effectLst/>
                        </a:rPr>
                        <a:t>Tnaiv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Galectin-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-0.329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0.0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3914884228"/>
                  </a:ext>
                </a:extLst>
              </a:tr>
              <a:tr h="3538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CD8 </a:t>
                      </a:r>
                      <a:r>
                        <a:rPr lang="en-US" sz="1400" u="none" strike="noStrike" dirty="0" err="1">
                          <a:effectLst/>
                        </a:rPr>
                        <a:t>Tnaiv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CXCL11/I-TA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-0.234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0.0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3443727219"/>
                  </a:ext>
                </a:extLst>
              </a:tr>
              <a:tr h="3538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CD8 </a:t>
                      </a:r>
                      <a:r>
                        <a:rPr lang="en-US" sz="1400" u="none" strike="noStrike" dirty="0" err="1">
                          <a:effectLst/>
                        </a:rPr>
                        <a:t>Tnaiv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TNF RI/TNFRSF1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-0.272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0.0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69185179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4FD7E1DB-D7A3-AD30-1C49-19298AF88013}"/>
              </a:ext>
            </a:extLst>
          </p:cNvPr>
          <p:cNvSpPr txBox="1"/>
          <p:nvPr/>
        </p:nvSpPr>
        <p:spPr>
          <a:xfrm>
            <a:off x="648933" y="3784064"/>
            <a:ext cx="22795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u="none" strike="noStrike" dirty="0">
                <a:effectLst/>
              </a:rPr>
              <a:t>CD8 TEM </a:t>
            </a:r>
            <a:endParaRPr lang="ja-JP" altLang="en-US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C5E87FBE-C65D-99DF-3098-910F872039AB}"/>
              </a:ext>
            </a:extLst>
          </p:cNvPr>
          <p:cNvSpPr txBox="1"/>
          <p:nvPr/>
        </p:nvSpPr>
        <p:spPr>
          <a:xfrm rot="16200000">
            <a:off x="-918631" y="2301671"/>
            <a:ext cx="2282083" cy="2842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200" u="none" strike="noStrike" dirty="0">
                <a:effectLst/>
              </a:rPr>
              <a:t>IL-8/CXCL8</a:t>
            </a:r>
            <a:endParaRPr lang="en-US" altLang="ja-JP" sz="1200" b="0" i="0" u="none" strike="noStrike" dirty="0">
              <a:solidFill>
                <a:srgbClr val="000000"/>
              </a:solidFill>
              <a:effectLst/>
              <a:latin typeface="游ゴシック" panose="020B0400000000000000" pitchFamily="50" charset="-128"/>
              <a:ea typeface="游ゴシック" panose="020B0400000000000000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067B2100-B1FE-EA7B-DAA5-33A013F8CBF1}"/>
              </a:ext>
            </a:extLst>
          </p:cNvPr>
          <p:cNvSpPr txBox="1"/>
          <p:nvPr/>
        </p:nvSpPr>
        <p:spPr>
          <a:xfrm rot="16200000">
            <a:off x="2032357" y="2302358"/>
            <a:ext cx="22777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200" u="none" strike="noStrike" dirty="0">
                <a:effectLst/>
              </a:rPr>
              <a:t>Galectin-9</a:t>
            </a:r>
            <a:endParaRPr lang="en-US" altLang="ja-JP" sz="1200" b="0" i="0" u="none" strike="noStrike" dirty="0">
              <a:solidFill>
                <a:srgbClr val="000000"/>
              </a:solidFill>
              <a:effectLst/>
              <a:latin typeface="游ゴシック" panose="020B0400000000000000" pitchFamily="50" charset="-128"/>
              <a:ea typeface="游ゴシック" panose="020B0400000000000000" pitchFamily="50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0416307A-0D06-512D-A9AA-382A498C5AB0}"/>
              </a:ext>
            </a:extLst>
          </p:cNvPr>
          <p:cNvSpPr txBox="1"/>
          <p:nvPr/>
        </p:nvSpPr>
        <p:spPr>
          <a:xfrm rot="16200000">
            <a:off x="5114743" y="2304908"/>
            <a:ext cx="22828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200" u="none" strike="noStrike" dirty="0">
                <a:effectLst/>
              </a:rPr>
              <a:t>CXCL11/I-TAC</a:t>
            </a:r>
            <a:endParaRPr lang="en-US" altLang="ja-JP" sz="1200" b="0" i="0" u="none" strike="noStrike" dirty="0">
              <a:solidFill>
                <a:srgbClr val="000000"/>
              </a:solidFill>
              <a:effectLst/>
              <a:latin typeface="游ゴシック" panose="020B0400000000000000" pitchFamily="50" charset="-128"/>
              <a:ea typeface="游ゴシック" panose="020B0400000000000000" pitchFamily="50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262324C3-4F1C-2EAC-8288-A91B845F62B0}"/>
              </a:ext>
            </a:extLst>
          </p:cNvPr>
          <p:cNvSpPr txBox="1"/>
          <p:nvPr/>
        </p:nvSpPr>
        <p:spPr>
          <a:xfrm rot="16200000">
            <a:off x="8020439" y="2303620"/>
            <a:ext cx="2277783" cy="2744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200" dirty="0"/>
              <a:t>TNF RI</a:t>
            </a:r>
            <a:r>
              <a:rPr lang="en-US" altLang="ja-JP" sz="1200" u="none" strike="noStrike" dirty="0">
                <a:effectLst/>
              </a:rPr>
              <a:t>/TNFRSF1A</a:t>
            </a:r>
            <a:endParaRPr lang="en-US" altLang="ja-JP" sz="1200" b="0" i="0" u="none" strike="noStrike" dirty="0">
              <a:solidFill>
                <a:srgbClr val="000000"/>
              </a:solidFill>
              <a:effectLst/>
              <a:latin typeface="游ゴシック" panose="020B0400000000000000" pitchFamily="50" charset="-128"/>
              <a:ea typeface="游ゴシック" panose="020B0400000000000000" pitchFamily="50" charset="-128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82752FEC-E99D-3844-3CEB-2B7959A0BDA5}"/>
              </a:ext>
            </a:extLst>
          </p:cNvPr>
          <p:cNvSpPr txBox="1"/>
          <p:nvPr/>
        </p:nvSpPr>
        <p:spPr>
          <a:xfrm>
            <a:off x="6631216" y="3780347"/>
            <a:ext cx="22580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u="none" strike="noStrike" dirty="0">
                <a:effectLst/>
              </a:rPr>
              <a:t>CD8 </a:t>
            </a:r>
            <a:r>
              <a:rPr lang="en-US" altLang="ja-JP" sz="1200" u="none" strike="noStrike" dirty="0" err="1">
                <a:effectLst/>
              </a:rPr>
              <a:t>Tnaive</a:t>
            </a:r>
            <a:r>
              <a:rPr lang="en-US" altLang="ja-JP" sz="1200" u="none" strike="noStrike" dirty="0">
                <a:effectLst/>
              </a:rPr>
              <a:t> </a:t>
            </a:r>
            <a:endParaRPr lang="ja-JP" altLang="en-US" sz="1200" dirty="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xmlns="" id="{DF5A2A82-AE7A-444B-BA9D-9E2B62D8534D}"/>
              </a:ext>
            </a:extLst>
          </p:cNvPr>
          <p:cNvSpPr/>
          <p:nvPr/>
        </p:nvSpPr>
        <p:spPr>
          <a:xfrm>
            <a:off x="306600" y="1088571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xmlns="" id="{47A13867-2000-DB14-C879-4DE6A5F22F40}"/>
              </a:ext>
            </a:extLst>
          </p:cNvPr>
          <p:cNvSpPr/>
          <p:nvPr/>
        </p:nvSpPr>
        <p:spPr>
          <a:xfrm>
            <a:off x="2817562" y="3686624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xmlns="" id="{B747E0FD-FE2D-4678-69C3-A32594CD4FA3}"/>
              </a:ext>
            </a:extLst>
          </p:cNvPr>
          <p:cNvSpPr/>
          <p:nvPr/>
        </p:nvSpPr>
        <p:spPr>
          <a:xfrm>
            <a:off x="6257426" y="1074060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xmlns="" id="{EF611157-CD89-44C0-93D6-333BC70E2871}"/>
              </a:ext>
            </a:extLst>
          </p:cNvPr>
          <p:cNvSpPr/>
          <p:nvPr/>
        </p:nvSpPr>
        <p:spPr>
          <a:xfrm>
            <a:off x="8768388" y="3672113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xmlns="" id="{214DC95D-D2EF-D493-5F1D-7CB1FF5AA5E6}"/>
              </a:ext>
            </a:extLst>
          </p:cNvPr>
          <p:cNvSpPr/>
          <p:nvPr/>
        </p:nvSpPr>
        <p:spPr>
          <a:xfrm>
            <a:off x="9298152" y="1074061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xmlns="" id="{DAFF4674-8A1E-91AF-9069-57D9AA91DF56}"/>
              </a:ext>
            </a:extLst>
          </p:cNvPr>
          <p:cNvSpPr/>
          <p:nvPr/>
        </p:nvSpPr>
        <p:spPr>
          <a:xfrm>
            <a:off x="11809114" y="3672114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xmlns="" id="{B64E6F92-0203-23E9-9242-2460B867CA0D}"/>
              </a:ext>
            </a:extLst>
          </p:cNvPr>
          <p:cNvSpPr/>
          <p:nvPr/>
        </p:nvSpPr>
        <p:spPr>
          <a:xfrm>
            <a:off x="3376353" y="1081320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xmlns="" id="{CBBC873C-ABEE-EEBA-BA21-C2F957DE7002}"/>
              </a:ext>
            </a:extLst>
          </p:cNvPr>
          <p:cNvSpPr/>
          <p:nvPr/>
        </p:nvSpPr>
        <p:spPr>
          <a:xfrm>
            <a:off x="5887315" y="3679373"/>
            <a:ext cx="27699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B6B1D35-2881-37D9-0ED0-B1E061CA071A}"/>
              </a:ext>
            </a:extLst>
          </p:cNvPr>
          <p:cNvSpPr txBox="1"/>
          <p:nvPr/>
        </p:nvSpPr>
        <p:spPr>
          <a:xfrm>
            <a:off x="9657432" y="3780350"/>
            <a:ext cx="22580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u="none" strike="noStrike" dirty="0">
                <a:effectLst/>
              </a:rPr>
              <a:t>CD8 </a:t>
            </a:r>
            <a:r>
              <a:rPr lang="en-US" altLang="ja-JP" sz="1200" u="none" strike="noStrike" dirty="0" err="1">
                <a:effectLst/>
              </a:rPr>
              <a:t>Tnaive</a:t>
            </a:r>
            <a:r>
              <a:rPr lang="en-US" altLang="ja-JP" sz="1200" u="none" strike="noStrike" dirty="0">
                <a:effectLst/>
              </a:rPr>
              <a:t> </a:t>
            </a:r>
            <a:endParaRPr lang="ja-JP" altLang="en-US" sz="12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B9D253F9-9766-7F41-20CE-6CDED5CAC3E7}"/>
              </a:ext>
            </a:extLst>
          </p:cNvPr>
          <p:cNvSpPr txBox="1"/>
          <p:nvPr/>
        </p:nvSpPr>
        <p:spPr>
          <a:xfrm>
            <a:off x="3729025" y="3780390"/>
            <a:ext cx="22580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u="none" strike="noStrike" dirty="0">
                <a:effectLst/>
              </a:rPr>
              <a:t>CD8 </a:t>
            </a:r>
            <a:r>
              <a:rPr lang="en-US" altLang="ja-JP" sz="1200" u="none" strike="noStrike" dirty="0" err="1">
                <a:effectLst/>
              </a:rPr>
              <a:t>Tnaive</a:t>
            </a:r>
            <a:r>
              <a:rPr lang="en-US" altLang="ja-JP" sz="1200" u="none" strike="noStrike" dirty="0">
                <a:effectLst/>
              </a:rPr>
              <a:t>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726023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1</TotalTime>
  <Words>81</Words>
  <Application>Microsoft Office PowerPoint</Application>
  <PresentationFormat>Custom</PresentationFormat>
  <Paragraphs>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ORTE   M.Tsunoda</cp:lastModifiedBy>
  <cp:revision>21</cp:revision>
  <dcterms:created xsi:type="dcterms:W3CDTF">2024-03-01T04:19:47Z</dcterms:created>
  <dcterms:modified xsi:type="dcterms:W3CDTF">2024-03-13T01:04:35Z</dcterms:modified>
</cp:coreProperties>
</file>